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7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B8F45CE-0ACA-2847-78A9-B97215C9DC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13C89C0D-72A0-2BCB-9F2E-E018D2FC0F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A215953-A15B-04DB-94C9-98E2F30A9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9AE8355-7048-05C7-FEB2-018AB58D7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982C8B3-803C-AD5D-92CE-42EA213FD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15388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74E083D-DE0E-A520-6B8C-FCAF991F7B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431D680F-D3E9-9A9E-E35C-DCF278F9E8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86BD016D-7A33-5962-38EB-5D436D673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E972145-E9FE-5F33-72D3-9CA5DBC0F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E421166A-08A1-6150-A364-3F335C0CD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50625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16A0E152-991D-1400-4ACC-BF7313D22A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B466C096-49DE-CFE0-39BC-5798AF66F4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219DBCD-72A3-6A5E-F9FD-0C28A7912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F6E9C58-80B9-3DB1-52AC-7EEFE4B18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4BE37E9A-B16E-E14D-D154-C05D8AB1E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10469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373E6D6-DFB7-ECB3-14C1-B7E6BC062C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909845EE-690C-BFA0-1926-76CA16121E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763914C7-F75A-2E06-0695-C90F3AC31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689B0BD-D9DC-8BE1-6D49-536424F97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ACA3990-40F1-D4C5-A7AE-09F42D6A5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92199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1EDF0E6-BE37-6581-591D-84DBF3373E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ADFA8CC8-FC5B-0A74-0D14-32F7CEE1AA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4217D22-75F2-1279-BFF6-E9CB3BE25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789B38D-B700-E738-5506-B90B4D9EC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5918B9D-8C62-D2CA-67A6-CB7A3DCAA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56548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FFA1919-BCEF-82E9-9E07-8293EE39E0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C11B7922-F3D0-8913-D3EA-501252C7D9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B210A24D-AB7F-3B31-A267-3E4926199B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F5290FBB-3885-A2CB-4B27-555D23E74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C0EC057F-D382-02FB-9B03-D408348FD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4FE3B86E-9152-93AC-D070-5816CD3D4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02831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4DC9CFD-91D3-F9A2-4540-D3C2E5058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EE7B8541-F12B-D549-F4E9-029945794D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875EFC20-5B98-B56C-593C-136FDC8E5D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57D54828-E374-8717-BB31-5763F196E1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BD8A6084-0A35-6E62-9A7E-BCCD7E19A4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30675506-028B-3ECE-C7F4-F2694501D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DA52F231-DB9A-735C-4F07-0493D514B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93D117E7-57CC-0892-E808-ABF3B0F25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68556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ECE5027-97F6-DEB3-8143-62DAEF4A10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45F9225F-8197-986B-3AFF-6DA8BD1E1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5FAADB9F-2CA7-58F2-9383-9BDB487BF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D36A5171-C67A-4E69-C6B6-DBBFC0C40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2678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97BC5761-9913-D15E-8E6E-C5AC80A5D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469BBD46-2631-1576-E75B-EA7DE08F5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19796006-B459-5A8D-ED90-011055CA2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69643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BE555BF-F758-DA45-45DE-273C5A5E1C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7496DB3C-514A-DDE3-550F-A38458E241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4CE4743F-81C3-5B61-2E47-C795098ED6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F728E7F1-4DF3-DE17-AB7E-F67C88D13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571590F7-710B-1AD8-1A9F-D2832F87C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EB1ED099-FE1F-D801-46EB-F4E16627BB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91561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F64E922-310E-6CF8-D030-17B30B1155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B501A5D2-FABD-AC43-53C1-FD694ED166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0C2F5EE3-BD40-5537-F281-622E28FA7E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1ACBB37-BBF1-7A50-8B29-2A903A23F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57561311-8759-6E9F-7D85-757BAA888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2484D75-9014-B03A-E937-294DED99B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33516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C86C287E-BB4B-9615-D455-10E0296C7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F2D9D8E3-D65C-6B31-C8AB-C93FB18706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DE581F6-CF04-A431-DCC5-85B13A9682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DC07F6-9DC1-4361-BFB0-3CEDC0B5F455}" type="datetimeFigureOut">
              <a:rPr lang="zh-TW" altLang="en-US" smtClean="0"/>
              <a:t>2024/9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F121FAD-2534-EA78-A2CD-7021857AE4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3BD9DF3-05A0-69F1-AB16-40A6FB5529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7D259-F7A9-4656-A7F8-527920BA431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05947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8ABE3CC7-A129-C1D1-AB57-7347222266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5943" y="0"/>
            <a:ext cx="9980930" cy="6653954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837B554C-2680-208B-F309-60577609AF67}"/>
              </a:ext>
            </a:extLst>
          </p:cNvPr>
          <p:cNvSpPr/>
          <p:nvPr/>
        </p:nvSpPr>
        <p:spPr>
          <a:xfrm>
            <a:off x="3593432" y="1752220"/>
            <a:ext cx="4291268" cy="291869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cxnSp>
        <p:nvCxnSpPr>
          <p:cNvPr id="10" name="直線接點 9">
            <a:extLst>
              <a:ext uri="{FF2B5EF4-FFF2-40B4-BE49-F238E27FC236}">
                <a16:creationId xmlns:a16="http://schemas.microsoft.com/office/drawing/2014/main" id="{44A723AF-D414-794D-9C49-131E46979F46}"/>
              </a:ext>
            </a:extLst>
          </p:cNvPr>
          <p:cNvCxnSpPr/>
          <p:nvPr/>
        </p:nvCxnSpPr>
        <p:spPr>
          <a:xfrm>
            <a:off x="3146882" y="1587320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接點 10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126522" y="1734452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接點 11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126521" y="2587561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2608810" y="1253174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2604492" y="1387771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2708149" y="2115360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40</a:t>
            </a:r>
            <a:endParaRPr lang="zh-TW" altLang="en-US" dirty="0"/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2679151" y="1510590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75</a:t>
            </a:r>
            <a:endParaRPr lang="zh-TW" altLang="en-US" dirty="0"/>
          </a:p>
        </p:txBody>
      </p:sp>
      <p:cxnSp>
        <p:nvCxnSpPr>
          <p:cNvPr id="17" name="直線接點 16">
            <a:extLst>
              <a:ext uri="{FF2B5EF4-FFF2-40B4-BE49-F238E27FC236}">
                <a16:creationId xmlns:a16="http://schemas.microsoft.com/office/drawing/2014/main" id="{98B6F265-6BD2-9029-64E3-9CF3CAF65BC4}"/>
              </a:ext>
            </a:extLst>
          </p:cNvPr>
          <p:cNvCxnSpPr>
            <a:cxnSpLocks/>
          </p:cNvCxnSpPr>
          <p:nvPr/>
        </p:nvCxnSpPr>
        <p:spPr>
          <a:xfrm>
            <a:off x="3702648" y="1600739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AC4C0A8E-FBBE-C9DC-ECEA-2CC9087302EC}"/>
              </a:ext>
            </a:extLst>
          </p:cNvPr>
          <p:cNvSpPr txBox="1"/>
          <p:nvPr/>
        </p:nvSpPr>
        <p:spPr>
          <a:xfrm>
            <a:off x="4574470" y="1128674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3149070" y="147950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接點 22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126883" y="1928915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2700129" y="1727223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2716171" y="2380054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27" name="直線接點 26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134905" y="2296208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接點 28">
            <a:extLst>
              <a:ext uri="{FF2B5EF4-FFF2-40B4-BE49-F238E27FC236}">
                <a16:creationId xmlns:a16="http://schemas.microsoft.com/office/drawing/2014/main" id="{748C6908-95D0-DAB6-56A0-CFABC296A640}"/>
              </a:ext>
            </a:extLst>
          </p:cNvPr>
          <p:cNvCxnSpPr>
            <a:cxnSpLocks/>
          </p:cNvCxnSpPr>
          <p:nvPr/>
        </p:nvCxnSpPr>
        <p:spPr>
          <a:xfrm>
            <a:off x="5896408" y="1587320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35C49913-4633-5091-4F9C-3A6CCCE9F80D}"/>
              </a:ext>
            </a:extLst>
          </p:cNvPr>
          <p:cNvSpPr txBox="1"/>
          <p:nvPr/>
        </p:nvSpPr>
        <p:spPr>
          <a:xfrm>
            <a:off x="2604492" y="368968"/>
            <a:ext cx="262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Perigonadal fat  </a:t>
            </a:r>
            <a:endParaRPr lang="zh-TW" altLang="en-US" sz="2800" dirty="0"/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CFDC3B3F-0CFC-D136-A033-DDF4FC7D005B}"/>
              </a:ext>
            </a:extLst>
          </p:cNvPr>
          <p:cNvSpPr txBox="1"/>
          <p:nvPr/>
        </p:nvSpPr>
        <p:spPr>
          <a:xfrm>
            <a:off x="8712617" y="1661908"/>
            <a:ext cx="8642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 err="1"/>
              <a:t>pAkt</a:t>
            </a:r>
            <a:endParaRPr lang="zh-TW" altLang="en-US" sz="2800" dirty="0"/>
          </a:p>
        </p:txBody>
      </p:sp>
    </p:spTree>
    <p:extLst>
      <p:ext uri="{BB962C8B-B14F-4D97-AF65-F5344CB8AC3E}">
        <p14:creationId xmlns:p14="http://schemas.microsoft.com/office/powerpoint/2010/main" val="300134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44D44BAE-70C6-4F84-F7E3-56E789EE74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224" y="0"/>
            <a:ext cx="10368000" cy="6858000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B9BE7177-7C1C-D59A-FBE6-9925354E292E}"/>
              </a:ext>
            </a:extLst>
          </p:cNvPr>
          <p:cNvSpPr/>
          <p:nvPr/>
        </p:nvSpPr>
        <p:spPr>
          <a:xfrm>
            <a:off x="4203025" y="4517414"/>
            <a:ext cx="4482843" cy="362795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D7F936D9-12C5-4247-DED2-2E236C2606FF}"/>
              </a:ext>
            </a:extLst>
          </p:cNvPr>
          <p:cNvSpPr txBox="1"/>
          <p:nvPr/>
        </p:nvSpPr>
        <p:spPr>
          <a:xfrm>
            <a:off x="2764910" y="2936941"/>
            <a:ext cx="8784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 smtClean="0"/>
              <a:t>Liver</a:t>
            </a:r>
            <a:endParaRPr lang="zh-TW" altLang="en-US" sz="2800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C118782E-BBD4-1FA5-E662-16688F6C2F59}"/>
              </a:ext>
            </a:extLst>
          </p:cNvPr>
          <p:cNvSpPr txBox="1"/>
          <p:nvPr/>
        </p:nvSpPr>
        <p:spPr>
          <a:xfrm>
            <a:off x="9382554" y="4370210"/>
            <a:ext cx="9103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dirty="0"/>
              <a:t> Akt</a:t>
            </a:r>
            <a:endParaRPr lang="zh-TW" altLang="en-US" sz="2800" dirty="0"/>
          </a:p>
        </p:txBody>
      </p:sp>
      <p:cxnSp>
        <p:nvCxnSpPr>
          <p:cNvPr id="19" name="直線接點 18">
            <a:extLst>
              <a:ext uri="{FF2B5EF4-FFF2-40B4-BE49-F238E27FC236}">
                <a16:creationId xmlns:a16="http://schemas.microsoft.com/office/drawing/2014/main" id="{017E28E4-B9C8-69FA-B0C3-73DD8667BA36}"/>
              </a:ext>
            </a:extLst>
          </p:cNvPr>
          <p:cNvCxnSpPr>
            <a:cxnSpLocks/>
          </p:cNvCxnSpPr>
          <p:nvPr/>
        </p:nvCxnSpPr>
        <p:spPr>
          <a:xfrm>
            <a:off x="4376410" y="4408118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437DE3F5-129D-245C-1CD7-42F8B96C63F8}"/>
              </a:ext>
            </a:extLst>
          </p:cNvPr>
          <p:cNvSpPr txBox="1"/>
          <p:nvPr/>
        </p:nvSpPr>
        <p:spPr>
          <a:xfrm>
            <a:off x="5248232" y="3936053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21" name="直線接點 20">
            <a:extLst>
              <a:ext uri="{FF2B5EF4-FFF2-40B4-BE49-F238E27FC236}">
                <a16:creationId xmlns:a16="http://schemas.microsoft.com/office/drawing/2014/main" id="{F43FD7E2-F314-8954-8C0D-564DE1299575}"/>
              </a:ext>
            </a:extLst>
          </p:cNvPr>
          <p:cNvCxnSpPr>
            <a:cxnSpLocks/>
          </p:cNvCxnSpPr>
          <p:nvPr/>
        </p:nvCxnSpPr>
        <p:spPr>
          <a:xfrm>
            <a:off x="6570170" y="4394699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D349C749-C3E3-D475-C33E-71F07F105498}"/>
              </a:ext>
            </a:extLst>
          </p:cNvPr>
          <p:cNvCxnSpPr/>
          <p:nvPr/>
        </p:nvCxnSpPr>
        <p:spPr>
          <a:xfrm>
            <a:off x="3564888" y="4314049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接點 27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557592" y="4700494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接點 28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557591" y="5421437"/>
            <a:ext cx="2137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3039880" y="4100881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3035562" y="4260068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3139219" y="4950772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3110221" y="4502758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34" name="直線接點 33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3567077" y="4457844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接點 34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557953" y="484193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3131199" y="4679434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3147240" y="5228529"/>
            <a:ext cx="424045" cy="369332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38" name="直線接點 37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565975" y="5116253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接點 38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566299" y="5704467"/>
            <a:ext cx="2137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3155948" y="5524622"/>
            <a:ext cx="424045" cy="369332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25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2490039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E387B972-8790-F6B8-34D0-0D8046F0CB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406" y="171288"/>
            <a:ext cx="9290223" cy="6181386"/>
          </a:xfrm>
          <a:prstGeom prst="rect">
            <a:avLst/>
          </a:prstGeom>
        </p:spPr>
      </p:pic>
      <p:sp>
        <p:nvSpPr>
          <p:cNvPr id="3" name="文字方塊 2">
            <a:extLst>
              <a:ext uri="{FF2B5EF4-FFF2-40B4-BE49-F238E27FC236}">
                <a16:creationId xmlns:a16="http://schemas.microsoft.com/office/drawing/2014/main" id="{B00A557E-C21B-BEB7-A7CE-8463006F610C}"/>
              </a:ext>
            </a:extLst>
          </p:cNvPr>
          <p:cNvSpPr txBox="1"/>
          <p:nvPr/>
        </p:nvSpPr>
        <p:spPr>
          <a:xfrm>
            <a:off x="2604492" y="368968"/>
            <a:ext cx="26237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Perigonadal fat  </a:t>
            </a:r>
            <a:endParaRPr lang="zh-TW" altLang="en-US" sz="2800" dirty="0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046B2491-DF7A-33D2-B984-D63141940246}"/>
              </a:ext>
            </a:extLst>
          </p:cNvPr>
          <p:cNvSpPr/>
          <p:nvPr/>
        </p:nvSpPr>
        <p:spPr>
          <a:xfrm>
            <a:off x="3785936" y="1591800"/>
            <a:ext cx="4186990" cy="317211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680F5FB6-45A2-18FB-9F51-2273B5CBDD72}"/>
              </a:ext>
            </a:extLst>
          </p:cNvPr>
          <p:cNvSpPr txBox="1"/>
          <p:nvPr/>
        </p:nvSpPr>
        <p:spPr>
          <a:xfrm>
            <a:off x="8070935" y="1501488"/>
            <a:ext cx="6750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Akt</a:t>
            </a:r>
            <a:endParaRPr lang="zh-TW" altLang="en-US" sz="2800" dirty="0"/>
          </a:p>
        </p:txBody>
      </p:sp>
      <p:cxnSp>
        <p:nvCxnSpPr>
          <p:cNvPr id="19" name="直線接點 18">
            <a:extLst>
              <a:ext uri="{FF2B5EF4-FFF2-40B4-BE49-F238E27FC236}">
                <a16:creationId xmlns:a16="http://schemas.microsoft.com/office/drawing/2014/main" id="{2A36FBC9-8C01-7C1B-38A8-B7D38D22CEAC}"/>
              </a:ext>
            </a:extLst>
          </p:cNvPr>
          <p:cNvCxnSpPr>
            <a:cxnSpLocks/>
          </p:cNvCxnSpPr>
          <p:nvPr/>
        </p:nvCxnSpPr>
        <p:spPr>
          <a:xfrm>
            <a:off x="3766816" y="1472403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1F910BE6-1539-202B-ECF5-57158452B4F1}"/>
              </a:ext>
            </a:extLst>
          </p:cNvPr>
          <p:cNvSpPr txBox="1"/>
          <p:nvPr/>
        </p:nvSpPr>
        <p:spPr>
          <a:xfrm>
            <a:off x="4590512" y="1080548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21" name="直線接點 20">
            <a:extLst>
              <a:ext uri="{FF2B5EF4-FFF2-40B4-BE49-F238E27FC236}">
                <a16:creationId xmlns:a16="http://schemas.microsoft.com/office/drawing/2014/main" id="{F9BDA19A-42D1-689C-EC8B-4CC29910A869}"/>
              </a:ext>
            </a:extLst>
          </p:cNvPr>
          <p:cNvCxnSpPr>
            <a:cxnSpLocks/>
          </p:cNvCxnSpPr>
          <p:nvPr/>
        </p:nvCxnSpPr>
        <p:spPr>
          <a:xfrm>
            <a:off x="5912450" y="1491068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接點 23">
            <a:extLst>
              <a:ext uri="{FF2B5EF4-FFF2-40B4-BE49-F238E27FC236}">
                <a16:creationId xmlns:a16="http://schemas.microsoft.com/office/drawing/2014/main" id="{44A723AF-D414-794D-9C49-131E46979F46}"/>
              </a:ext>
            </a:extLst>
          </p:cNvPr>
          <p:cNvCxnSpPr/>
          <p:nvPr/>
        </p:nvCxnSpPr>
        <p:spPr>
          <a:xfrm>
            <a:off x="3146882" y="1600383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139585" y="1696031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139584" y="2534541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2608810" y="1187859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2604492" y="1360109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2708149" y="2116128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2679151" y="1511358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31" name="直線接點 30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3149070" y="1492570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接點 31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139946" y="1837474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2700129" y="1674971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2716171" y="2380822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35" name="直線接點 34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147968" y="2294672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410795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2EA84EDB-6EE3-4293-EFBC-5AC71BB460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8723" y="0"/>
            <a:ext cx="10287001" cy="6858000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50DF4B4C-C912-8A06-0E03-0F7491FA73BF}"/>
              </a:ext>
            </a:extLst>
          </p:cNvPr>
          <p:cNvSpPr/>
          <p:nvPr/>
        </p:nvSpPr>
        <p:spPr>
          <a:xfrm>
            <a:off x="3513222" y="1196689"/>
            <a:ext cx="4363452" cy="299223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66314D3E-0014-DC3D-D213-5744AB71B4FA}"/>
              </a:ext>
            </a:extLst>
          </p:cNvPr>
          <p:cNvSpPr txBox="1"/>
          <p:nvPr/>
        </p:nvSpPr>
        <p:spPr>
          <a:xfrm>
            <a:off x="2604492" y="51522"/>
            <a:ext cx="18991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Inguinal fat </a:t>
            </a:r>
            <a:endParaRPr lang="zh-TW" altLang="en-US" sz="2800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F9F2EF2F-BED5-0DFA-9A3D-4713FF5C9390}"/>
              </a:ext>
            </a:extLst>
          </p:cNvPr>
          <p:cNvSpPr txBox="1"/>
          <p:nvPr/>
        </p:nvSpPr>
        <p:spPr>
          <a:xfrm>
            <a:off x="7974682" y="1036267"/>
            <a:ext cx="8642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 err="1"/>
              <a:t>pAkt</a:t>
            </a:r>
            <a:endParaRPr lang="zh-TW" altLang="en-US" sz="2800" dirty="0"/>
          </a:p>
        </p:txBody>
      </p:sp>
      <p:cxnSp>
        <p:nvCxnSpPr>
          <p:cNvPr id="27" name="直線接點 26">
            <a:extLst>
              <a:ext uri="{FF2B5EF4-FFF2-40B4-BE49-F238E27FC236}">
                <a16:creationId xmlns:a16="http://schemas.microsoft.com/office/drawing/2014/main" id="{D3749913-1F68-B2BC-3E4A-855239931D65}"/>
              </a:ext>
            </a:extLst>
          </p:cNvPr>
          <p:cNvCxnSpPr>
            <a:cxnSpLocks/>
          </p:cNvCxnSpPr>
          <p:nvPr/>
        </p:nvCxnSpPr>
        <p:spPr>
          <a:xfrm>
            <a:off x="3686606" y="1039267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2DD49A31-BFA0-B5E6-7510-93FCEE8FED6C}"/>
              </a:ext>
            </a:extLst>
          </p:cNvPr>
          <p:cNvSpPr txBox="1"/>
          <p:nvPr/>
        </p:nvSpPr>
        <p:spPr>
          <a:xfrm>
            <a:off x="4558428" y="567202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29" name="直線接點 28">
            <a:extLst>
              <a:ext uri="{FF2B5EF4-FFF2-40B4-BE49-F238E27FC236}">
                <a16:creationId xmlns:a16="http://schemas.microsoft.com/office/drawing/2014/main" id="{41BEED24-A0B6-84CC-DA03-49F62AE0DA3D}"/>
              </a:ext>
            </a:extLst>
          </p:cNvPr>
          <p:cNvCxnSpPr>
            <a:cxnSpLocks/>
          </p:cNvCxnSpPr>
          <p:nvPr/>
        </p:nvCxnSpPr>
        <p:spPr>
          <a:xfrm>
            <a:off x="5880366" y="1025848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D349C749-C3E3-D475-C33E-71F07F105498}"/>
              </a:ext>
            </a:extLst>
          </p:cNvPr>
          <p:cNvCxnSpPr/>
          <p:nvPr/>
        </p:nvCxnSpPr>
        <p:spPr>
          <a:xfrm>
            <a:off x="3133818" y="956888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接點 23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126522" y="1343333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126521" y="2142654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2608810" y="795972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2604492" y="955159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2708149" y="1724241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2679151" y="1119471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33" name="直線接點 32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3136007" y="1139872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接點 33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126883" y="144558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2700129" y="1283084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2716171" y="1988935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37" name="直線接點 36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134905" y="1902785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49419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4C456D7D-ACAE-7245-C1E0-F4C0CE699E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583" y="0"/>
            <a:ext cx="10253579" cy="6858000"/>
          </a:xfrm>
          <a:prstGeom prst="rect">
            <a:avLst/>
          </a:prstGeom>
        </p:spPr>
      </p:pic>
      <p:sp>
        <p:nvSpPr>
          <p:cNvPr id="4" name="文字方塊 3">
            <a:extLst>
              <a:ext uri="{FF2B5EF4-FFF2-40B4-BE49-F238E27FC236}">
                <a16:creationId xmlns:a16="http://schemas.microsoft.com/office/drawing/2014/main" id="{07C3387D-55FB-5791-2B08-1145B240CF49}"/>
              </a:ext>
            </a:extLst>
          </p:cNvPr>
          <p:cNvSpPr txBox="1"/>
          <p:nvPr/>
        </p:nvSpPr>
        <p:spPr>
          <a:xfrm>
            <a:off x="2308812" y="683030"/>
            <a:ext cx="18991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Inguinal fat </a:t>
            </a:r>
            <a:endParaRPr lang="zh-TW" altLang="en-US" sz="2800" dirty="0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39D49159-5277-EA69-23D1-1550F1F740E8}"/>
              </a:ext>
            </a:extLst>
          </p:cNvPr>
          <p:cNvSpPr/>
          <p:nvPr/>
        </p:nvSpPr>
        <p:spPr>
          <a:xfrm>
            <a:off x="2988931" y="2183460"/>
            <a:ext cx="4363452" cy="299223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cxnSp>
        <p:nvCxnSpPr>
          <p:cNvPr id="19" name="直線接點 18">
            <a:extLst>
              <a:ext uri="{FF2B5EF4-FFF2-40B4-BE49-F238E27FC236}">
                <a16:creationId xmlns:a16="http://schemas.microsoft.com/office/drawing/2014/main" id="{AE81106A-73D6-C7B0-40E7-5F23266F9EFC}"/>
              </a:ext>
            </a:extLst>
          </p:cNvPr>
          <p:cNvCxnSpPr>
            <a:cxnSpLocks/>
          </p:cNvCxnSpPr>
          <p:nvPr/>
        </p:nvCxnSpPr>
        <p:spPr>
          <a:xfrm>
            <a:off x="3028881" y="2001794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A8D6CDD7-851B-1198-A52F-3956FC3C9CFD}"/>
              </a:ext>
            </a:extLst>
          </p:cNvPr>
          <p:cNvSpPr txBox="1"/>
          <p:nvPr/>
        </p:nvSpPr>
        <p:spPr>
          <a:xfrm>
            <a:off x="3900703" y="1529729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21" name="直線接點 20">
            <a:extLst>
              <a:ext uri="{FF2B5EF4-FFF2-40B4-BE49-F238E27FC236}">
                <a16:creationId xmlns:a16="http://schemas.microsoft.com/office/drawing/2014/main" id="{71112AE7-D8DB-5FCF-1D04-EF4B7AEB829A}"/>
              </a:ext>
            </a:extLst>
          </p:cNvPr>
          <p:cNvCxnSpPr>
            <a:cxnSpLocks/>
          </p:cNvCxnSpPr>
          <p:nvPr/>
        </p:nvCxnSpPr>
        <p:spPr>
          <a:xfrm>
            <a:off x="5222641" y="1988375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743466B9-25C0-0022-80FF-A5FD48557027}"/>
              </a:ext>
            </a:extLst>
          </p:cNvPr>
          <p:cNvSpPr txBox="1"/>
          <p:nvPr/>
        </p:nvSpPr>
        <p:spPr>
          <a:xfrm>
            <a:off x="7525507" y="2079003"/>
            <a:ext cx="6750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Akt</a:t>
            </a:r>
            <a:endParaRPr lang="zh-TW" altLang="en-US" sz="2800" dirty="0"/>
          </a:p>
        </p:txBody>
      </p: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D349C749-C3E3-D475-C33E-71F07F105498}"/>
              </a:ext>
            </a:extLst>
          </p:cNvPr>
          <p:cNvCxnSpPr/>
          <p:nvPr/>
        </p:nvCxnSpPr>
        <p:spPr>
          <a:xfrm>
            <a:off x="2702743" y="1832102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2695447" y="221854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2695446" y="305705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2177735" y="1671186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2173417" y="1830373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2277074" y="2638644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2248076" y="2033874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31" name="直線接點 30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2704932" y="2015086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接點 31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2695808" y="2359990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2269054" y="2197487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2285096" y="2903338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35" name="直線接點 34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2703830" y="2817188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082304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24F007DE-B1D4-DDDF-5226-3E0D742975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130" y="28074"/>
            <a:ext cx="10318982" cy="6829926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484089B1-9F28-0B9B-4D41-7690E7DF82C9}"/>
              </a:ext>
            </a:extLst>
          </p:cNvPr>
          <p:cNvSpPr/>
          <p:nvPr/>
        </p:nvSpPr>
        <p:spPr>
          <a:xfrm>
            <a:off x="3625515" y="2704651"/>
            <a:ext cx="4482843" cy="362795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873DFB56-7DC3-283E-E4F8-75817F6E290A}"/>
              </a:ext>
            </a:extLst>
          </p:cNvPr>
          <p:cNvSpPr txBox="1"/>
          <p:nvPr/>
        </p:nvSpPr>
        <p:spPr>
          <a:xfrm>
            <a:off x="2716786" y="1477167"/>
            <a:ext cx="32873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Brown adipose tissue</a:t>
            </a:r>
            <a:endParaRPr lang="zh-TW" altLang="en-US" sz="2800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7DC70709-7592-F23C-5D78-B49A68709A4F}"/>
              </a:ext>
            </a:extLst>
          </p:cNvPr>
          <p:cNvSpPr txBox="1"/>
          <p:nvPr/>
        </p:nvSpPr>
        <p:spPr>
          <a:xfrm>
            <a:off x="8086976" y="2576313"/>
            <a:ext cx="8642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 err="1"/>
              <a:t>pAkt</a:t>
            </a:r>
            <a:endParaRPr lang="zh-TW" altLang="en-US" sz="2800" dirty="0"/>
          </a:p>
        </p:txBody>
      </p:sp>
      <p:cxnSp>
        <p:nvCxnSpPr>
          <p:cNvPr id="20" name="直線接點 19">
            <a:extLst>
              <a:ext uri="{FF2B5EF4-FFF2-40B4-BE49-F238E27FC236}">
                <a16:creationId xmlns:a16="http://schemas.microsoft.com/office/drawing/2014/main" id="{D39FAB0B-D61B-97B0-420B-6A8CFAB5E789}"/>
              </a:ext>
            </a:extLst>
          </p:cNvPr>
          <p:cNvCxnSpPr>
            <a:cxnSpLocks/>
          </p:cNvCxnSpPr>
          <p:nvPr/>
        </p:nvCxnSpPr>
        <p:spPr>
          <a:xfrm>
            <a:off x="3798900" y="2579313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3B570523-43D5-BB76-9380-F1BCA9BA1DD9}"/>
              </a:ext>
            </a:extLst>
          </p:cNvPr>
          <p:cNvSpPr txBox="1"/>
          <p:nvPr/>
        </p:nvSpPr>
        <p:spPr>
          <a:xfrm>
            <a:off x="4670722" y="2107248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AC460D0A-D88E-5164-7568-5EB7BFFCCA9D}"/>
              </a:ext>
            </a:extLst>
          </p:cNvPr>
          <p:cNvCxnSpPr>
            <a:cxnSpLocks/>
          </p:cNvCxnSpPr>
          <p:nvPr/>
        </p:nvCxnSpPr>
        <p:spPr>
          <a:xfrm>
            <a:off x="5992660" y="2565894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接點 22">
            <a:extLst>
              <a:ext uri="{FF2B5EF4-FFF2-40B4-BE49-F238E27FC236}">
                <a16:creationId xmlns:a16="http://schemas.microsoft.com/office/drawing/2014/main" id="{D349C749-C3E3-D475-C33E-71F07F105498}"/>
              </a:ext>
            </a:extLst>
          </p:cNvPr>
          <p:cNvCxnSpPr/>
          <p:nvPr/>
        </p:nvCxnSpPr>
        <p:spPr>
          <a:xfrm>
            <a:off x="3368946" y="2406872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361650" y="279331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361649" y="363182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2843938" y="2245956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2839620" y="2405143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2943277" y="3213414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2914279" y="2608644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31" name="直線接點 30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3371135" y="2589856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接點 31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362011" y="2934760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2935257" y="2772257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2951299" y="3478108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35" name="直線接點 34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370033" y="3391958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910272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圖片 23">
            <a:extLst>
              <a:ext uri="{FF2B5EF4-FFF2-40B4-BE49-F238E27FC236}">
                <a16:creationId xmlns:a16="http://schemas.microsoft.com/office/drawing/2014/main" id="{CB17C323-AFD6-D63A-B398-AB57B24E23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056" y="0"/>
            <a:ext cx="10347870" cy="6858000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BEAEAA1B-8086-B946-C111-6C7546876763}"/>
              </a:ext>
            </a:extLst>
          </p:cNvPr>
          <p:cNvSpPr/>
          <p:nvPr/>
        </p:nvSpPr>
        <p:spPr>
          <a:xfrm>
            <a:off x="3994481" y="2207348"/>
            <a:ext cx="4482843" cy="362795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6A9BF911-B4BA-0B7D-EEFA-E02162BE08BB}"/>
              </a:ext>
            </a:extLst>
          </p:cNvPr>
          <p:cNvSpPr txBox="1"/>
          <p:nvPr/>
        </p:nvSpPr>
        <p:spPr>
          <a:xfrm>
            <a:off x="3085752" y="979864"/>
            <a:ext cx="32873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Brown adipose tissue</a:t>
            </a:r>
            <a:endParaRPr lang="zh-TW" altLang="en-US" sz="2800" dirty="0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93B923D9-913D-EE4F-0B3D-B89A2DFDCC54}"/>
              </a:ext>
            </a:extLst>
          </p:cNvPr>
          <p:cNvSpPr txBox="1"/>
          <p:nvPr/>
        </p:nvSpPr>
        <p:spPr>
          <a:xfrm>
            <a:off x="8570526" y="2079010"/>
            <a:ext cx="9103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dirty="0"/>
              <a:t> Akt</a:t>
            </a:r>
            <a:endParaRPr lang="zh-TW" altLang="en-US" sz="2800" dirty="0"/>
          </a:p>
        </p:txBody>
      </p:sp>
      <p:cxnSp>
        <p:nvCxnSpPr>
          <p:cNvPr id="18" name="直線接點 17">
            <a:extLst>
              <a:ext uri="{FF2B5EF4-FFF2-40B4-BE49-F238E27FC236}">
                <a16:creationId xmlns:a16="http://schemas.microsoft.com/office/drawing/2014/main" id="{4D4882D5-26F3-5256-F104-5CAA309DE4E3}"/>
              </a:ext>
            </a:extLst>
          </p:cNvPr>
          <p:cNvCxnSpPr>
            <a:cxnSpLocks/>
          </p:cNvCxnSpPr>
          <p:nvPr/>
        </p:nvCxnSpPr>
        <p:spPr>
          <a:xfrm>
            <a:off x="4167866" y="2082010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5FF5BA98-BAD7-1C79-5B6E-9313B09196A8}"/>
              </a:ext>
            </a:extLst>
          </p:cNvPr>
          <p:cNvSpPr txBox="1"/>
          <p:nvPr/>
        </p:nvSpPr>
        <p:spPr>
          <a:xfrm>
            <a:off x="5039688" y="1609945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20" name="直線接點 19">
            <a:extLst>
              <a:ext uri="{FF2B5EF4-FFF2-40B4-BE49-F238E27FC236}">
                <a16:creationId xmlns:a16="http://schemas.microsoft.com/office/drawing/2014/main" id="{C6BDBB35-DD8B-75CC-77FB-5AE5EBBBB577}"/>
              </a:ext>
            </a:extLst>
          </p:cNvPr>
          <p:cNvCxnSpPr>
            <a:cxnSpLocks/>
          </p:cNvCxnSpPr>
          <p:nvPr/>
        </p:nvCxnSpPr>
        <p:spPr>
          <a:xfrm>
            <a:off x="6361626" y="2068591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接點 22">
            <a:extLst>
              <a:ext uri="{FF2B5EF4-FFF2-40B4-BE49-F238E27FC236}">
                <a16:creationId xmlns:a16="http://schemas.microsoft.com/office/drawing/2014/main" id="{44A723AF-D414-794D-9C49-131E46979F46}"/>
              </a:ext>
            </a:extLst>
          </p:cNvPr>
          <p:cNvCxnSpPr/>
          <p:nvPr/>
        </p:nvCxnSpPr>
        <p:spPr>
          <a:xfrm>
            <a:off x="3577955" y="2135961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570658" y="2270798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570657" y="3109308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3052946" y="1723437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3048628" y="1882624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3152285" y="2690895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3123287" y="2073062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31" name="直線接點 30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3580143" y="2028148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接點 31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571019" y="2412241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3144265" y="2249738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3160307" y="2955589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35" name="直線接點 34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579041" y="2869439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962138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FD754854-1F67-AC6F-C651-3D11015BEE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170" y="89674"/>
            <a:ext cx="10408980" cy="6858000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960CF49F-639C-2C14-4386-7B3E27079FD6}"/>
              </a:ext>
            </a:extLst>
          </p:cNvPr>
          <p:cNvSpPr/>
          <p:nvPr/>
        </p:nvSpPr>
        <p:spPr>
          <a:xfrm>
            <a:off x="3625515" y="2369853"/>
            <a:ext cx="4482843" cy="373917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9DEC42CD-E666-C9B0-7690-B6A0E962CC93}"/>
              </a:ext>
            </a:extLst>
          </p:cNvPr>
          <p:cNvSpPr txBox="1"/>
          <p:nvPr/>
        </p:nvSpPr>
        <p:spPr>
          <a:xfrm>
            <a:off x="2716786" y="1076117"/>
            <a:ext cx="24992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Skeletal muscle </a:t>
            </a:r>
            <a:endParaRPr lang="zh-TW" altLang="en-US" sz="2800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CB34728D-8A36-C025-6487-FA025CF8C607}"/>
              </a:ext>
            </a:extLst>
          </p:cNvPr>
          <p:cNvSpPr txBox="1"/>
          <p:nvPr/>
        </p:nvSpPr>
        <p:spPr>
          <a:xfrm>
            <a:off x="8086976" y="2175263"/>
            <a:ext cx="8642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 err="1"/>
              <a:t>pAkt</a:t>
            </a:r>
            <a:endParaRPr lang="zh-TW" altLang="en-US" sz="2800" dirty="0"/>
          </a:p>
        </p:txBody>
      </p:sp>
      <p:cxnSp>
        <p:nvCxnSpPr>
          <p:cNvPr id="20" name="直線接點 19">
            <a:extLst>
              <a:ext uri="{FF2B5EF4-FFF2-40B4-BE49-F238E27FC236}">
                <a16:creationId xmlns:a16="http://schemas.microsoft.com/office/drawing/2014/main" id="{395CE02C-86D2-0B36-9922-08C0EB7A9936}"/>
              </a:ext>
            </a:extLst>
          </p:cNvPr>
          <p:cNvCxnSpPr>
            <a:cxnSpLocks/>
          </p:cNvCxnSpPr>
          <p:nvPr/>
        </p:nvCxnSpPr>
        <p:spPr>
          <a:xfrm>
            <a:off x="3798900" y="2178263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ACCFD8CF-DC75-8F3D-1C32-FFD5728AC110}"/>
              </a:ext>
            </a:extLst>
          </p:cNvPr>
          <p:cNvSpPr txBox="1"/>
          <p:nvPr/>
        </p:nvSpPr>
        <p:spPr>
          <a:xfrm>
            <a:off x="4670722" y="1706198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8A4BAC39-4F68-761A-E19D-96C881331FDB}"/>
              </a:ext>
            </a:extLst>
          </p:cNvPr>
          <p:cNvCxnSpPr>
            <a:cxnSpLocks/>
          </p:cNvCxnSpPr>
          <p:nvPr/>
        </p:nvCxnSpPr>
        <p:spPr>
          <a:xfrm>
            <a:off x="5992660" y="2164844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接點 23">
            <a:extLst>
              <a:ext uri="{FF2B5EF4-FFF2-40B4-BE49-F238E27FC236}">
                <a16:creationId xmlns:a16="http://schemas.microsoft.com/office/drawing/2014/main" id="{44A723AF-D414-794D-9C49-131E46979F46}"/>
              </a:ext>
            </a:extLst>
          </p:cNvPr>
          <p:cNvCxnSpPr/>
          <p:nvPr/>
        </p:nvCxnSpPr>
        <p:spPr>
          <a:xfrm>
            <a:off x="3342823" y="2344969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335526" y="2479806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335525" y="3318316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2817814" y="1971634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2813496" y="2117758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2917153" y="2899903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2888155" y="2282070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31" name="直線接點 30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3345011" y="2237156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接點 31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335887" y="2621249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2909133" y="2458746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2925175" y="3164597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35" name="直線接點 34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343909" y="307844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630674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圖片 22">
            <a:extLst>
              <a:ext uri="{FF2B5EF4-FFF2-40B4-BE49-F238E27FC236}">
                <a16:creationId xmlns:a16="http://schemas.microsoft.com/office/drawing/2014/main" id="{2C83598C-6358-747C-C8CF-B8CB34529D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07" y="0"/>
            <a:ext cx="10233421" cy="6858000"/>
          </a:xfrm>
          <a:prstGeom prst="rect">
            <a:avLst/>
          </a:prstGeom>
        </p:spPr>
      </p:pic>
      <p:sp>
        <p:nvSpPr>
          <p:cNvPr id="37" name="矩形 36">
            <a:extLst>
              <a:ext uri="{FF2B5EF4-FFF2-40B4-BE49-F238E27FC236}">
                <a16:creationId xmlns:a16="http://schemas.microsoft.com/office/drawing/2014/main" id="{1C3B7400-6650-ED0F-10EC-7EC050CACE0F}"/>
              </a:ext>
            </a:extLst>
          </p:cNvPr>
          <p:cNvSpPr/>
          <p:nvPr/>
        </p:nvSpPr>
        <p:spPr>
          <a:xfrm>
            <a:off x="4507825" y="1918592"/>
            <a:ext cx="4482843" cy="362795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611000D5-D47B-4C81-7735-BC839D3AA5AB}"/>
              </a:ext>
            </a:extLst>
          </p:cNvPr>
          <p:cNvSpPr txBox="1"/>
          <p:nvPr/>
        </p:nvSpPr>
        <p:spPr>
          <a:xfrm>
            <a:off x="3069710" y="338119"/>
            <a:ext cx="24174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Skeletal muscle</a:t>
            </a:r>
            <a:endParaRPr lang="zh-TW" altLang="en-US" sz="2800" dirty="0"/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AD999564-71AA-69FF-81FE-4D32A80FDB76}"/>
              </a:ext>
            </a:extLst>
          </p:cNvPr>
          <p:cNvSpPr txBox="1"/>
          <p:nvPr/>
        </p:nvSpPr>
        <p:spPr>
          <a:xfrm>
            <a:off x="9083870" y="1806296"/>
            <a:ext cx="9103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dirty="0"/>
              <a:t> Akt</a:t>
            </a:r>
            <a:endParaRPr lang="zh-TW" altLang="en-US" sz="2800" dirty="0"/>
          </a:p>
        </p:txBody>
      </p:sp>
      <p:cxnSp>
        <p:nvCxnSpPr>
          <p:cNvPr id="40" name="直線接點 39">
            <a:extLst>
              <a:ext uri="{FF2B5EF4-FFF2-40B4-BE49-F238E27FC236}">
                <a16:creationId xmlns:a16="http://schemas.microsoft.com/office/drawing/2014/main" id="{0B80FA5F-3477-8145-4903-802381403583}"/>
              </a:ext>
            </a:extLst>
          </p:cNvPr>
          <p:cNvCxnSpPr>
            <a:cxnSpLocks/>
          </p:cNvCxnSpPr>
          <p:nvPr/>
        </p:nvCxnSpPr>
        <p:spPr>
          <a:xfrm>
            <a:off x="4681210" y="1809296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503D2CC0-C071-CCCD-185B-C5309368C515}"/>
              </a:ext>
            </a:extLst>
          </p:cNvPr>
          <p:cNvSpPr txBox="1"/>
          <p:nvPr/>
        </p:nvSpPr>
        <p:spPr>
          <a:xfrm>
            <a:off x="5553032" y="1337231"/>
            <a:ext cx="2509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KO </a:t>
            </a:r>
            <a:endParaRPr lang="zh-TW" altLang="en-US" dirty="0"/>
          </a:p>
        </p:txBody>
      </p:sp>
      <p:cxnSp>
        <p:nvCxnSpPr>
          <p:cNvPr id="42" name="直線接點 41">
            <a:extLst>
              <a:ext uri="{FF2B5EF4-FFF2-40B4-BE49-F238E27FC236}">
                <a16:creationId xmlns:a16="http://schemas.microsoft.com/office/drawing/2014/main" id="{F802CA1D-6F23-18E2-1C06-94B0904EA69E}"/>
              </a:ext>
            </a:extLst>
          </p:cNvPr>
          <p:cNvCxnSpPr>
            <a:cxnSpLocks/>
          </p:cNvCxnSpPr>
          <p:nvPr/>
        </p:nvCxnSpPr>
        <p:spPr>
          <a:xfrm>
            <a:off x="6874970" y="1795877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接點 42">
            <a:extLst>
              <a:ext uri="{FF2B5EF4-FFF2-40B4-BE49-F238E27FC236}">
                <a16:creationId xmlns:a16="http://schemas.microsoft.com/office/drawing/2014/main" id="{44A723AF-D414-794D-9C49-131E46979F46}"/>
              </a:ext>
            </a:extLst>
          </p:cNvPr>
          <p:cNvCxnSpPr/>
          <p:nvPr/>
        </p:nvCxnSpPr>
        <p:spPr>
          <a:xfrm>
            <a:off x="3708582" y="1887766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接點 43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701285" y="2048729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接點 44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701284" y="2887239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3183573" y="1527494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3179255" y="1673618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3282912" y="2468826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3253914" y="1850993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50" name="直線接點 49">
            <a:extLst>
              <a:ext uri="{FF2B5EF4-FFF2-40B4-BE49-F238E27FC236}">
                <a16:creationId xmlns:a16="http://schemas.microsoft.com/office/drawing/2014/main" id="{2E2A3EBE-CE3A-FDD8-7707-B822036F225D}"/>
              </a:ext>
            </a:extLst>
          </p:cNvPr>
          <p:cNvCxnSpPr/>
          <p:nvPr/>
        </p:nvCxnSpPr>
        <p:spPr>
          <a:xfrm>
            <a:off x="3710770" y="1740764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接點 50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701646" y="2190172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3274892" y="2027669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53" name="文字方塊 52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3290934" y="2733520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54" name="直線接點 53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709668" y="2647370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726798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57B34778-2F5C-BDCB-D12D-69980C028C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641" y="0"/>
            <a:ext cx="10390718" cy="6845968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AEA8B48F-2684-A249-A029-E8C134BF22DE}"/>
              </a:ext>
            </a:extLst>
          </p:cNvPr>
          <p:cNvSpPr/>
          <p:nvPr/>
        </p:nvSpPr>
        <p:spPr>
          <a:xfrm>
            <a:off x="3801977" y="2257559"/>
            <a:ext cx="4482843" cy="373917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B5604B99-C163-1B1A-85AE-6A5C5D51DC75}"/>
              </a:ext>
            </a:extLst>
          </p:cNvPr>
          <p:cNvSpPr txBox="1"/>
          <p:nvPr/>
        </p:nvSpPr>
        <p:spPr>
          <a:xfrm>
            <a:off x="2791444" y="1076117"/>
            <a:ext cx="24245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dirty="0"/>
              <a:t>Liver</a:t>
            </a:r>
            <a:endParaRPr lang="zh-TW" altLang="en-US" sz="2800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CEFB7FB5-F249-4597-13E5-71711754BF12}"/>
              </a:ext>
            </a:extLst>
          </p:cNvPr>
          <p:cNvSpPr txBox="1"/>
          <p:nvPr/>
        </p:nvSpPr>
        <p:spPr>
          <a:xfrm>
            <a:off x="8295522" y="2143179"/>
            <a:ext cx="8642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 err="1"/>
              <a:t>pAkt</a:t>
            </a:r>
            <a:endParaRPr lang="zh-TW" altLang="en-US" sz="2800" dirty="0"/>
          </a:p>
        </p:txBody>
      </p:sp>
      <p:cxnSp>
        <p:nvCxnSpPr>
          <p:cNvPr id="20" name="直線接點 19">
            <a:extLst>
              <a:ext uri="{FF2B5EF4-FFF2-40B4-BE49-F238E27FC236}">
                <a16:creationId xmlns:a16="http://schemas.microsoft.com/office/drawing/2014/main" id="{6873B2F3-2C2A-FD47-DD7C-7978D477E1D7}"/>
              </a:ext>
            </a:extLst>
          </p:cNvPr>
          <p:cNvCxnSpPr>
            <a:cxnSpLocks/>
          </p:cNvCxnSpPr>
          <p:nvPr/>
        </p:nvCxnSpPr>
        <p:spPr>
          <a:xfrm>
            <a:off x="3798900" y="2162221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C6534567-58D9-7AA4-CA75-BA04B5016217}"/>
              </a:ext>
            </a:extLst>
          </p:cNvPr>
          <p:cNvSpPr txBox="1"/>
          <p:nvPr/>
        </p:nvSpPr>
        <p:spPr>
          <a:xfrm>
            <a:off x="4670722" y="1706198"/>
            <a:ext cx="2773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WT                                     KO </a:t>
            </a:r>
            <a:endParaRPr lang="zh-TW" altLang="en-US" dirty="0"/>
          </a:p>
        </p:txBody>
      </p: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209D61BE-4E93-AF21-898C-C0E1D1F11172}"/>
              </a:ext>
            </a:extLst>
          </p:cNvPr>
          <p:cNvCxnSpPr>
            <a:cxnSpLocks/>
          </p:cNvCxnSpPr>
          <p:nvPr/>
        </p:nvCxnSpPr>
        <p:spPr>
          <a:xfrm>
            <a:off x="6201206" y="2164844"/>
            <a:ext cx="19882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接點 24">
            <a:extLst>
              <a:ext uri="{FF2B5EF4-FFF2-40B4-BE49-F238E27FC236}">
                <a16:creationId xmlns:a16="http://schemas.microsoft.com/office/drawing/2014/main" id="{D349C749-C3E3-D475-C33E-71F07F105498}"/>
              </a:ext>
            </a:extLst>
          </p:cNvPr>
          <p:cNvCxnSpPr/>
          <p:nvPr/>
        </p:nvCxnSpPr>
        <p:spPr>
          <a:xfrm>
            <a:off x="3564888" y="2132545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44A723AF-D414-794D-9C49-131E46979F46}"/>
              </a:ext>
            </a:extLst>
          </p:cNvPr>
          <p:cNvCxnSpPr/>
          <p:nvPr/>
        </p:nvCxnSpPr>
        <p:spPr>
          <a:xfrm>
            <a:off x="3564889" y="2279649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接點 26">
            <a:extLst>
              <a:ext uri="{FF2B5EF4-FFF2-40B4-BE49-F238E27FC236}">
                <a16:creationId xmlns:a16="http://schemas.microsoft.com/office/drawing/2014/main" id="{84F644C4-1281-7033-100E-FEBE55390E9B}"/>
              </a:ext>
            </a:extLst>
          </p:cNvPr>
          <p:cNvCxnSpPr/>
          <p:nvPr/>
        </p:nvCxnSpPr>
        <p:spPr>
          <a:xfrm>
            <a:off x="3557592" y="2414486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接點 27">
            <a:extLst>
              <a:ext uri="{FF2B5EF4-FFF2-40B4-BE49-F238E27FC236}">
                <a16:creationId xmlns:a16="http://schemas.microsoft.com/office/drawing/2014/main" id="{92D17C63-394F-01B8-9893-94D5DA6D6BF8}"/>
              </a:ext>
            </a:extLst>
          </p:cNvPr>
          <p:cNvCxnSpPr/>
          <p:nvPr/>
        </p:nvCxnSpPr>
        <p:spPr>
          <a:xfrm>
            <a:off x="3557591" y="3252996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0DD49DCA-4AE9-3171-E493-71EB08E156FE}"/>
              </a:ext>
            </a:extLst>
          </p:cNvPr>
          <p:cNvSpPr txBox="1"/>
          <p:nvPr/>
        </p:nvSpPr>
        <p:spPr>
          <a:xfrm>
            <a:off x="3039880" y="1906314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30</a:t>
            </a:r>
            <a:endParaRPr lang="zh-TW" altLang="en-US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39D0E73B-1F00-8564-937E-3DC7B7633F9E}"/>
              </a:ext>
            </a:extLst>
          </p:cNvPr>
          <p:cNvSpPr txBox="1"/>
          <p:nvPr/>
        </p:nvSpPr>
        <p:spPr>
          <a:xfrm>
            <a:off x="3035562" y="2052438"/>
            <a:ext cx="53572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100</a:t>
            </a:r>
            <a:endParaRPr lang="zh-TW" altLang="en-US" dirty="0"/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6DC900E8-D39E-049A-0CA7-3E3AEBE482A0}"/>
              </a:ext>
            </a:extLst>
          </p:cNvPr>
          <p:cNvSpPr txBox="1"/>
          <p:nvPr/>
        </p:nvSpPr>
        <p:spPr>
          <a:xfrm>
            <a:off x="3139219" y="2834583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48</a:t>
            </a:r>
            <a:endParaRPr lang="zh-TW" altLang="en-US" dirty="0"/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918B7543-E7BE-1981-7E1C-CC361A4A6CA6}"/>
              </a:ext>
            </a:extLst>
          </p:cNvPr>
          <p:cNvSpPr txBox="1"/>
          <p:nvPr/>
        </p:nvSpPr>
        <p:spPr>
          <a:xfrm>
            <a:off x="3110221" y="2216750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70</a:t>
            </a:r>
            <a:endParaRPr lang="zh-TW" altLang="en-US" dirty="0"/>
          </a:p>
        </p:txBody>
      </p:sp>
      <p:cxnSp>
        <p:nvCxnSpPr>
          <p:cNvPr id="34" name="直線接點 33">
            <a:extLst>
              <a:ext uri="{FF2B5EF4-FFF2-40B4-BE49-F238E27FC236}">
                <a16:creationId xmlns:a16="http://schemas.microsoft.com/office/drawing/2014/main" id="{B73F3999-59A5-6BCE-391B-4EF8F33CA94E}"/>
              </a:ext>
            </a:extLst>
          </p:cNvPr>
          <p:cNvCxnSpPr/>
          <p:nvPr/>
        </p:nvCxnSpPr>
        <p:spPr>
          <a:xfrm>
            <a:off x="3557953" y="2555929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5BF7F2C3-100D-000F-44F0-A5763E0EB4B7}"/>
              </a:ext>
            </a:extLst>
          </p:cNvPr>
          <p:cNvSpPr txBox="1"/>
          <p:nvPr/>
        </p:nvSpPr>
        <p:spPr>
          <a:xfrm>
            <a:off x="3131199" y="2393426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5</a:t>
            </a:r>
            <a:endParaRPr lang="zh-TW" altLang="en-US" dirty="0"/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5C5038AE-2CFC-1B5C-DC8D-9FB8623287B8}"/>
              </a:ext>
            </a:extLst>
          </p:cNvPr>
          <p:cNvSpPr txBox="1"/>
          <p:nvPr/>
        </p:nvSpPr>
        <p:spPr>
          <a:xfrm>
            <a:off x="3147241" y="3099277"/>
            <a:ext cx="418704" cy="369332"/>
          </a:xfrm>
          <a:prstGeom prst="rect">
            <a:avLst/>
          </a:prstGeom>
          <a:noFill/>
          <a:ln w="19050"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dirty="0"/>
              <a:t>35</a:t>
            </a:r>
            <a:endParaRPr lang="zh-TW" altLang="en-US" dirty="0"/>
          </a:p>
        </p:txBody>
      </p:sp>
      <p:cxnSp>
        <p:nvCxnSpPr>
          <p:cNvPr id="37" name="直線接點 36">
            <a:extLst>
              <a:ext uri="{FF2B5EF4-FFF2-40B4-BE49-F238E27FC236}">
                <a16:creationId xmlns:a16="http://schemas.microsoft.com/office/drawing/2014/main" id="{ED34FE89-91F2-EA9D-DED7-5382F7028008}"/>
              </a:ext>
            </a:extLst>
          </p:cNvPr>
          <p:cNvCxnSpPr/>
          <p:nvPr/>
        </p:nvCxnSpPr>
        <p:spPr>
          <a:xfrm>
            <a:off x="3565975" y="3013127"/>
            <a:ext cx="2110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6749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6</TotalTime>
  <Words>114</Words>
  <Application>Microsoft Office PowerPoint</Application>
  <PresentationFormat>寬螢幕</PresentationFormat>
  <Paragraphs>91</Paragraphs>
  <Slides>10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0</vt:i4>
      </vt:variant>
    </vt:vector>
  </HeadingPairs>
  <TitlesOfParts>
    <vt:vector size="15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以承 張</dc:creator>
  <cp:lastModifiedBy>Owner</cp:lastModifiedBy>
  <cp:revision>34</cp:revision>
  <dcterms:created xsi:type="dcterms:W3CDTF">2024-09-15T05:11:22Z</dcterms:created>
  <dcterms:modified xsi:type="dcterms:W3CDTF">2024-09-16T09:59:04Z</dcterms:modified>
</cp:coreProperties>
</file>